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43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541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748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7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195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250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2431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927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601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617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788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9878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724E9-6206-419C-8D60-A4036E71F612}" type="datetimeFigureOut">
              <a:rPr kumimoji="1" lang="ja-JP" altLang="en-US" smtClean="0"/>
              <a:t>2021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FA5D3A-C3BF-4306-8516-7B6B940146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1896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2749715"/>
              </p:ext>
            </p:extLst>
          </p:nvPr>
        </p:nvGraphicFramePr>
        <p:xfrm>
          <a:off x="83125" y="685790"/>
          <a:ext cx="8790710" cy="5538528"/>
        </p:xfrm>
        <a:graphic>
          <a:graphicData uri="http://schemas.openxmlformats.org/drawingml/2006/table">
            <a:tbl>
              <a:tblPr/>
              <a:tblGrid>
                <a:gridCol w="591893">
                  <a:extLst>
                    <a:ext uri="{9D8B030D-6E8A-4147-A177-3AD203B41FA5}">
                      <a16:colId xmlns:a16="http://schemas.microsoft.com/office/drawing/2014/main" val="101236220"/>
                    </a:ext>
                  </a:extLst>
                </a:gridCol>
                <a:gridCol w="1677031">
                  <a:extLst>
                    <a:ext uri="{9D8B030D-6E8A-4147-A177-3AD203B41FA5}">
                      <a16:colId xmlns:a16="http://schemas.microsoft.com/office/drawing/2014/main" val="1792222037"/>
                    </a:ext>
                  </a:extLst>
                </a:gridCol>
                <a:gridCol w="767269">
                  <a:extLst>
                    <a:ext uri="{9D8B030D-6E8A-4147-A177-3AD203B41FA5}">
                      <a16:colId xmlns:a16="http://schemas.microsoft.com/office/drawing/2014/main" val="3691598374"/>
                    </a:ext>
                  </a:extLst>
                </a:gridCol>
                <a:gridCol w="854957">
                  <a:extLst>
                    <a:ext uri="{9D8B030D-6E8A-4147-A177-3AD203B41FA5}">
                      <a16:colId xmlns:a16="http://schemas.microsoft.com/office/drawing/2014/main" val="191592004"/>
                    </a:ext>
                  </a:extLst>
                </a:gridCol>
                <a:gridCol w="591893">
                  <a:extLst>
                    <a:ext uri="{9D8B030D-6E8A-4147-A177-3AD203B41FA5}">
                      <a16:colId xmlns:a16="http://schemas.microsoft.com/office/drawing/2014/main" val="3175560136"/>
                    </a:ext>
                  </a:extLst>
                </a:gridCol>
                <a:gridCol w="591893">
                  <a:extLst>
                    <a:ext uri="{9D8B030D-6E8A-4147-A177-3AD203B41FA5}">
                      <a16:colId xmlns:a16="http://schemas.microsoft.com/office/drawing/2014/main" val="3459214493"/>
                    </a:ext>
                  </a:extLst>
                </a:gridCol>
                <a:gridCol w="2093548">
                  <a:extLst>
                    <a:ext uri="{9D8B030D-6E8A-4147-A177-3AD203B41FA5}">
                      <a16:colId xmlns:a16="http://schemas.microsoft.com/office/drawing/2014/main" val="456047278"/>
                    </a:ext>
                  </a:extLst>
                </a:gridCol>
                <a:gridCol w="767269">
                  <a:extLst>
                    <a:ext uri="{9D8B030D-6E8A-4147-A177-3AD203B41FA5}">
                      <a16:colId xmlns:a16="http://schemas.microsoft.com/office/drawing/2014/main" val="1068435064"/>
                    </a:ext>
                  </a:extLst>
                </a:gridCol>
                <a:gridCol w="854957">
                  <a:extLst>
                    <a:ext uri="{9D8B030D-6E8A-4147-A177-3AD203B41FA5}">
                      <a16:colId xmlns:a16="http://schemas.microsoft.com/office/drawing/2014/main" val="4020760744"/>
                    </a:ext>
                  </a:extLst>
                </a:gridCol>
              </a:tblGrid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o.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ormula name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ot number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yield ratio(%)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o.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ormula name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ot number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yield ratio(%)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61233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nchus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05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2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yukikyoga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59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.1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8007113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akumondoto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29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9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obushisaishi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88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.6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735804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oiog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20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.5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okubo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34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.9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7786092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ikujounta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65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.2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5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inji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32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2.9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9791320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otosa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45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.6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6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injinyoe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77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9.5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0772441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aibof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0068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7.9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Ogikench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71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2.8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0223370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aikench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73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5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ikkos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80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.8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6437568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oreis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0017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.1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ikkunsh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39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.3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2036237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orins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47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3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0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okumig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63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5.2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5088122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oshajinkig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76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.9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1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yokankyomishingeni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86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.1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49934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oshuy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31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.3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2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yokeijutsuka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37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6.6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3649075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achimijiog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0007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8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3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yokyojutsuka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85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.9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178721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angebyakujutsutemma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35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.0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aikokeishikankyo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11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0419553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angekobok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16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5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aikokeish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10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1.0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2965251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angeshashi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14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.6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aikoseika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80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.8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7247428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ochuekk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38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1.1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ishoekk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92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.2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5605741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Jidabokuipp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64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akanzo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50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.4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0566000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Jiinshiho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66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.5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akuyakukanzo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54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5972603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9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Jinsoi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53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.1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0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ichimotsukoka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43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.9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4112562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Juzentaiho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46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6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ikunsh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58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0.8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4234633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akko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01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.2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imb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0030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1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7388322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ambakutaiso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57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.6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imots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56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.0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4407930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amikih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93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.0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ohangekabukuryoto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21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.0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2443846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eih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89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0.8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okench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72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.1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3653677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eishibukuryog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25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.0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6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okiinsh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62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6.6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3115572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6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eishikajutsub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18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.3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7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okikench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87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2.1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9610457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7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eishikaryukotsubore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26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0.0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okishakuyakusa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50023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.1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1441126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eishikashakuyaku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48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2.3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9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okishigyakukagoshuyushokyo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36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.4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3324367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eishininjin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60061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1.6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ok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74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.3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2093350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eish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41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5.3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nke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75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5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614332"/>
                  </a:ext>
                </a:extLst>
              </a:tr>
              <a:tr h="17159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1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Kihito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40052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9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2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Yokukansan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70054010</a:t>
                      </a:r>
                    </a:p>
                  </a:txBody>
                  <a:tcPr marL="5439" marR="5439" marT="5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6.7 </a:t>
                      </a:r>
                    </a:p>
                  </a:txBody>
                  <a:tcPr marL="5439" marR="5439" marT="5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4192238"/>
                  </a:ext>
                </a:extLst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342902" y="270914"/>
            <a:ext cx="56845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1.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t numbers and yield ratios of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bal medicine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65317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78</Words>
  <Application>Microsoft Office PowerPoint</Application>
  <PresentationFormat>画面に合わせる (4:3)</PresentationFormat>
  <Paragraphs>25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常風 興平</dc:creator>
  <cp:lastModifiedBy>常風 興平</cp:lastModifiedBy>
  <cp:revision>1</cp:revision>
  <dcterms:created xsi:type="dcterms:W3CDTF">2021-12-15T09:29:27Z</dcterms:created>
  <dcterms:modified xsi:type="dcterms:W3CDTF">2021-12-15T09:31:23Z</dcterms:modified>
</cp:coreProperties>
</file>